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6" r:id="rId2"/>
    <p:sldId id="493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364"/>
    <p:restoredTop sz="94681"/>
  </p:normalViewPr>
  <p:slideViewPr>
    <p:cSldViewPr snapToGrid="0">
      <p:cViewPr varScale="1">
        <p:scale>
          <a:sx n="88" d="100"/>
          <a:sy n="88" d="100"/>
        </p:scale>
        <p:origin x="176" y="7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1674453-29DD-A748-8E99-5DA2856AB228}" type="datetimeFigureOut">
              <a:rPr lang="en-US" smtClean="0"/>
              <a:t>8/8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0A7CC5-112E-CA4C-90FA-C18C1BE2B6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52042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28600" indent="-228600">
              <a:buAutoNum type="alphaUcParenBoth"/>
            </a:pPr>
            <a:r>
              <a:rPr lang="en-US" dirty="0"/>
              <a:t>Fast (normal) contraction</a:t>
            </a:r>
          </a:p>
          <a:p>
            <a:pPr marL="228600" indent="-228600">
              <a:buAutoNum type="alphaUcParenBoth"/>
            </a:pPr>
            <a:r>
              <a:rPr lang="en-US" dirty="0"/>
              <a:t>Slow contraction</a:t>
            </a:r>
          </a:p>
          <a:p>
            <a:pPr marL="228600" indent="-228600">
              <a:buAutoNum type="alphaUcParenBoth"/>
            </a:pPr>
            <a:r>
              <a:rPr lang="en-US" dirty="0"/>
              <a:t>No contract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0C7658F-DC61-6649-9CB3-4CB4919BE582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3281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EB074C-5CF5-2282-356F-30420FF1848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ADC5222-67B5-827F-E581-750B1EAD35F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246C1B-2476-98FB-6AE7-B16A576833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30AC6-12C5-BF4E-8C95-7157ADC500A5}" type="datetimeFigureOut">
              <a:rPr lang="en-US" smtClean="0"/>
              <a:t>8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809E9E-C7BF-3061-E69E-28EF9E1293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C0F6DC-0F3A-6A5C-FF7E-56D0F3D472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D5C5F-FAD2-2043-B31D-C4B7ABAAC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5401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E6F9B4-BF8E-C04A-AE11-70645090C3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2691DDC-1ABA-1B76-7F2A-D343848117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5FE34D-40E7-B498-BF5F-E361E0E446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30AC6-12C5-BF4E-8C95-7157ADC500A5}" type="datetimeFigureOut">
              <a:rPr lang="en-US" smtClean="0"/>
              <a:t>8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4FB3FD-EAD5-6657-2B6C-5DF8D5B49B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2BD311-8D8B-B3BF-A7BF-F63663D113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D5C5F-FAD2-2043-B31D-C4B7ABAAC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1142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CBA4057-EC2F-AF6F-F11E-68DF8205904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A905931-3F4C-F54B-9C0B-6F2CE929CF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934F5B-AAAC-ABA5-57CE-6B97A64C0C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30AC6-12C5-BF4E-8C95-7157ADC500A5}" type="datetimeFigureOut">
              <a:rPr lang="en-US" smtClean="0"/>
              <a:t>8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26EDD7-8086-3841-6903-6D49AA5B25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9F4D4F-F68A-BBF6-8112-70A21A36CC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D5C5F-FAD2-2043-B31D-C4B7ABAAC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490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CAFD06-9A43-A6E7-2701-7432B80A26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210C6E-130F-31BD-2B07-D4D1DF7C0F7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1DC8D2-FA71-7F78-ADAB-EE4B57A9DF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30AC6-12C5-BF4E-8C95-7157ADC500A5}" type="datetimeFigureOut">
              <a:rPr lang="en-US" smtClean="0"/>
              <a:t>8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BF6E91-90DB-510A-44B6-C23F07741D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EF3F71-6A69-9B41-53B8-31A5D90541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D5C5F-FAD2-2043-B31D-C4B7ABAAC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1354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5A45BE-4866-429B-A1E5-41F7753162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EDF275-D572-244E-28A9-08FDB39428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640464-67F3-A1EA-17B6-DA3B636AA7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30AC6-12C5-BF4E-8C95-7157ADC500A5}" type="datetimeFigureOut">
              <a:rPr lang="en-US" smtClean="0"/>
              <a:t>8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71F48D-2AA6-0E66-0050-1CD80CB32D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BE52C8-C058-0AA2-6EC1-099E0C4B47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D5C5F-FAD2-2043-B31D-C4B7ABAAC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2142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1CA592-C478-45CD-CB1F-D4B9212BE8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73CB0D8-E1A4-9BDC-BA5D-860AFCA9827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6561A12-24B9-30C1-A933-42CF2E9B13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9CCCEE-547F-EF72-E1F4-4D3071F30C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30AC6-12C5-BF4E-8C95-7157ADC500A5}" type="datetimeFigureOut">
              <a:rPr lang="en-US" smtClean="0"/>
              <a:t>8/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5AD1E9-4B4F-AA99-6B87-15B5CFA49D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93CC4F-6748-0011-4798-8031871F1E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D5C5F-FAD2-2043-B31D-C4B7ABAAC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7055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35B40B-83FD-E7D7-22B4-C389D5E9E1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B070B9-0600-08F9-E9FA-BE5D850C45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846D405-37D7-5BBC-3211-1FE783B0D5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C8E37EF-6423-BCB8-54BC-06BA4B2639E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329540D-18D9-A5AC-D617-ED7708527B8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35AF52C-ED69-54BD-AF37-8E442FD535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30AC6-12C5-BF4E-8C95-7157ADC500A5}" type="datetimeFigureOut">
              <a:rPr lang="en-US" smtClean="0"/>
              <a:t>8/8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DAFDF1A-06BF-6179-7F5F-2B10D19183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CE7E697-2551-D5E5-FADE-B8D13D46BB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D5C5F-FAD2-2043-B31D-C4B7ABAAC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37324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116F6C-A12F-DF8F-D6EF-27D58BAB44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7C8A874-1CEF-7BA4-304B-445DA2C32B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30AC6-12C5-BF4E-8C95-7157ADC500A5}" type="datetimeFigureOut">
              <a:rPr lang="en-US" smtClean="0"/>
              <a:t>8/8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7576900-E743-798B-F9DD-BADDF1DE00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BC83DEA-7B78-6E93-CA3D-51D1374D71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D5C5F-FAD2-2043-B31D-C4B7ABAAC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5601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259812F-8DB4-C5F8-0130-1C8AB04C9E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30AC6-12C5-BF4E-8C95-7157ADC500A5}" type="datetimeFigureOut">
              <a:rPr lang="en-US" smtClean="0"/>
              <a:t>8/8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41368A1-4C2F-9616-598E-067A2689E3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8B832A2-57A6-8B23-DB79-EF3CE01D36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D5C5F-FAD2-2043-B31D-C4B7ABAAC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04184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1C1F43-2C77-83FA-98E1-464954A028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95248E-361D-E3A9-24E4-78A59A90DA8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4A5DEEE-9938-C006-B4DE-7DBC3E9794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D9D405-9F40-BBC0-2BC1-66EDC32952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30AC6-12C5-BF4E-8C95-7157ADC500A5}" type="datetimeFigureOut">
              <a:rPr lang="en-US" smtClean="0"/>
              <a:t>8/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F925163-D46C-4739-90F7-87548F0E8C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22823B7-9493-2542-997C-2B88D1F160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D5C5F-FAD2-2043-B31D-C4B7ABAAC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90224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EA9C0A-11FF-546A-6284-B77E74B55F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EDF20D8-9E62-E763-BA65-BF99EF565E7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023937E-1E65-886B-45EB-81B881FB92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D2F4ABC-C569-6AD3-57B9-00DF986D3E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30AC6-12C5-BF4E-8C95-7157ADC500A5}" type="datetimeFigureOut">
              <a:rPr lang="en-US" smtClean="0"/>
              <a:t>8/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206E9B-E655-916D-596F-106CFF2F02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8D84E9-738C-0A13-085A-7574D1041F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D5C5F-FAD2-2043-B31D-C4B7ABAAC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87304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083F273-31C2-E960-9E10-5ABD5A04AA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F07202-6ECC-10EB-61F6-7757E28683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4E2EC3-1EC5-9AF3-6133-C82184DD222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2530AC6-12C5-BF4E-8C95-7157ADC500A5}" type="datetimeFigureOut">
              <a:rPr lang="en-US" smtClean="0"/>
              <a:t>8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E79306-2320-D4AF-06AC-3949E769A60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3F9D39-EC79-029E-B7E2-C401474F472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1ED5C5F-FAD2-2043-B31D-C4B7ABAAC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8339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notesSlide" Target="../notesSlides/notesSlide1.xml"/><Relationship Id="rId3" Type="http://schemas.microsoft.com/office/2007/relationships/media" Target="../media/media2.avi"/><Relationship Id="rId7" Type="http://schemas.openxmlformats.org/officeDocument/2006/relationships/slideLayout" Target="../slideLayouts/slideLayout6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video" Target="../media/media3.avi"/><Relationship Id="rId11" Type="http://schemas.openxmlformats.org/officeDocument/2006/relationships/image" Target="../media/image3.png"/><Relationship Id="rId5" Type="http://schemas.microsoft.com/office/2007/relationships/media" Target="../media/media3.avi"/><Relationship Id="rId10" Type="http://schemas.openxmlformats.org/officeDocument/2006/relationships/image" Target="../media/image2.png"/><Relationship Id="rId4" Type="http://schemas.openxmlformats.org/officeDocument/2006/relationships/video" Target="../media/media2.avi"/><Relationship Id="rId9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393934-58C5-F0A0-AFC3-49E2044CABC7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9F1001C-E3CC-F521-38A2-BEF6AA4F6F74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25316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38C704-913E-B6DB-2F45-AF193574AB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097" y="-90352"/>
            <a:ext cx="10207795" cy="1325563"/>
          </a:xfrm>
        </p:spPr>
        <p:txBody>
          <a:bodyPr>
            <a:normAutofit/>
          </a:bodyPr>
          <a:lstStyle/>
          <a:p>
            <a:r>
              <a:rPr lang="en-US" sz="4000" dirty="0"/>
              <a:t>Supplementary Videos: Stentor contraction</a:t>
            </a:r>
          </a:p>
        </p:txBody>
      </p:sp>
      <p:pic>
        <p:nvPicPr>
          <p:cNvPr id="3" name="10021_cell1-1">
            <a:hlinkClick r:id="" action="ppaction://media"/>
            <a:extLst>
              <a:ext uri="{FF2B5EF4-FFF2-40B4-BE49-F238E27FC236}">
                <a16:creationId xmlns:a16="http://schemas.microsoft.com/office/drawing/2014/main" id="{57350BF9-DD77-F3A3-7E05-149AA735A74B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562287" y="1092797"/>
            <a:ext cx="3123644" cy="2014313"/>
          </a:xfrm>
          <a:prstGeom prst="rect">
            <a:avLst/>
          </a:prstGeom>
        </p:spPr>
      </p:pic>
      <p:pic>
        <p:nvPicPr>
          <p:cNvPr id="4" name="25893_cell4">
            <a:hlinkClick r:id="" action="ppaction://media"/>
            <a:extLst>
              <a:ext uri="{FF2B5EF4-FFF2-40B4-BE49-F238E27FC236}">
                <a16:creationId xmlns:a16="http://schemas.microsoft.com/office/drawing/2014/main" id="{8E96626D-FA82-1807-AA64-116C84CB51A1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3781687" y="1089080"/>
            <a:ext cx="3031983" cy="2122388"/>
          </a:xfrm>
          <a:prstGeom prst="rect">
            <a:avLst/>
          </a:prstGeom>
        </p:spPr>
      </p:pic>
      <p:pic>
        <p:nvPicPr>
          <p:cNvPr id="5" name="25973_cell1-2">
            <a:hlinkClick r:id="" action="ppaction://media"/>
            <a:extLst>
              <a:ext uri="{FF2B5EF4-FFF2-40B4-BE49-F238E27FC236}">
                <a16:creationId xmlns:a16="http://schemas.microsoft.com/office/drawing/2014/main" id="{B44AA0A8-1025-F821-9342-B786C860900C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1"/>
          <a:stretch>
            <a:fillRect/>
          </a:stretch>
        </p:blipFill>
        <p:spPr>
          <a:xfrm>
            <a:off x="6909426" y="1089080"/>
            <a:ext cx="3497453" cy="212238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F1B7D2F-4494-F7D7-6102-8D3051698A93}"/>
              </a:ext>
            </a:extLst>
          </p:cNvPr>
          <p:cNvSpPr txBox="1"/>
          <p:nvPr/>
        </p:nvSpPr>
        <p:spPr>
          <a:xfrm>
            <a:off x="6733146" y="824711"/>
            <a:ext cx="267731" cy="2680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42" b="1" dirty="0"/>
              <a:t>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04F07C1-33D3-3052-611B-7BE7D49790E4}"/>
              </a:ext>
            </a:extLst>
          </p:cNvPr>
          <p:cNvSpPr txBox="1"/>
          <p:nvPr/>
        </p:nvSpPr>
        <p:spPr>
          <a:xfrm>
            <a:off x="3594480" y="824710"/>
            <a:ext cx="260678" cy="2680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42" b="1" dirty="0"/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7B9EF35-1F6C-756B-20D6-43DAB8C31BBA}"/>
              </a:ext>
            </a:extLst>
          </p:cNvPr>
          <p:cNvSpPr txBox="1"/>
          <p:nvPr/>
        </p:nvSpPr>
        <p:spPr>
          <a:xfrm>
            <a:off x="195884" y="826394"/>
            <a:ext cx="260678" cy="2680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42" b="1" dirty="0"/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0E9E7BF-9B50-C3AB-FB8E-B91E0698D0DD}"/>
              </a:ext>
            </a:extLst>
          </p:cNvPr>
          <p:cNvSpPr txBox="1"/>
          <p:nvPr/>
        </p:nvSpPr>
        <p:spPr>
          <a:xfrm>
            <a:off x="963827" y="3211468"/>
            <a:ext cx="21270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ormal contraction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A1B51BD-BBFF-DDB6-20AE-748DAF1D4D9A}"/>
              </a:ext>
            </a:extLst>
          </p:cNvPr>
          <p:cNvSpPr txBox="1"/>
          <p:nvPr/>
        </p:nvSpPr>
        <p:spPr>
          <a:xfrm>
            <a:off x="4485503" y="3211468"/>
            <a:ext cx="18603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low contractio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2BA74A1-0260-EAAE-B623-E98E1A744D51}"/>
              </a:ext>
            </a:extLst>
          </p:cNvPr>
          <p:cNvSpPr txBox="1"/>
          <p:nvPr/>
        </p:nvSpPr>
        <p:spPr>
          <a:xfrm>
            <a:off x="7823051" y="3211468"/>
            <a:ext cx="16702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o contraction</a:t>
            </a:r>
          </a:p>
        </p:txBody>
      </p:sp>
    </p:spTree>
    <p:extLst>
      <p:ext uri="{BB962C8B-B14F-4D97-AF65-F5344CB8AC3E}">
        <p14:creationId xmlns:p14="http://schemas.microsoft.com/office/powerpoint/2010/main" val="116436914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2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520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212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0" fill="hold">
                            <p:stCondLst>
                              <p:cond delay="2640"/>
                            </p:stCondLst>
                            <p:childTnLst>
                              <p:par>
                                <p:cTn id="11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2" dur="27820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13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4" fill="hold">
                      <p:stCondLst>
                        <p:cond delay="0"/>
                      </p:stCondLst>
                      <p:childTnLst>
                        <p:par>
                          <p:cTn id="15" fill="hold">
                            <p:stCondLst>
                              <p:cond delay="0"/>
                            </p:stCondLst>
                            <p:childTnLst>
                              <p:par>
                                <p:cTn id="16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7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18" repeatCount="indefinite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19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0" fill="hold">
                      <p:stCondLst>
                        <p:cond delay="0"/>
                      </p:stCondLst>
                      <p:childTnLst>
                        <p:par>
                          <p:cTn id="21" fill="hold">
                            <p:stCondLst>
                              <p:cond delay="0"/>
                            </p:stCondLst>
                            <p:childTnLst>
                              <p:par>
                                <p:cTn id="22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3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24" repeatCount="indefinite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25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6" fill="hold">
                      <p:stCondLst>
                        <p:cond delay="0"/>
                      </p:stCondLst>
                      <p:childTnLst>
                        <p:par>
                          <p:cTn id="27" fill="hold">
                            <p:stCondLst>
                              <p:cond delay="0"/>
                            </p:stCondLst>
                            <p:childTnLst>
                              <p:par>
                                <p:cTn id="28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9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30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</Words>
  <Application>Microsoft Macintosh PowerPoint</Application>
  <PresentationFormat>Widescreen</PresentationFormat>
  <Paragraphs>11</Paragraphs>
  <Slides>2</Slides>
  <Notes>1</Notes>
  <HiddenSlides>0</HiddenSlides>
  <MMClips>3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Supplementary Videos: Stentor contrac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an, Connie</dc:creator>
  <cp:lastModifiedBy>Yan, Connie</cp:lastModifiedBy>
  <cp:revision>1</cp:revision>
  <dcterms:created xsi:type="dcterms:W3CDTF">2025-08-08T19:01:38Z</dcterms:created>
  <dcterms:modified xsi:type="dcterms:W3CDTF">2025-08-08T19:02:06Z</dcterms:modified>
</cp:coreProperties>
</file>